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8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102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162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5368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922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2162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48329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852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940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159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075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464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3D3B3-3451-4910-9F3F-0D72F41322F0}" type="datetimeFigureOut">
              <a:rPr lang="en-US" smtClean="0"/>
              <a:t>9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E2C2BD-EA05-474E-B637-CECE947F98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5557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694" y="312205"/>
            <a:ext cx="5476875" cy="17907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378219" y="2102905"/>
            <a:ext cx="1271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dfa_Jun16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5694" y="2443662"/>
            <a:ext cx="5476875" cy="1819275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2378219" y="4259788"/>
            <a:ext cx="127182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dfa_Jun18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5693" y="4625971"/>
            <a:ext cx="5476875" cy="1889236"/>
          </a:xfrm>
          <a:prstGeom prst="rect">
            <a:avLst/>
          </a:prstGeom>
        </p:spPr>
      </p:pic>
      <p:sp>
        <p:nvSpPr>
          <p:cNvPr id="9" name="Rectangle 8"/>
          <p:cNvSpPr/>
          <p:nvPr/>
        </p:nvSpPr>
        <p:spPr>
          <a:xfrm>
            <a:off x="2378219" y="6508909"/>
            <a:ext cx="18737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dulation_Jun15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02362" y="314270"/>
            <a:ext cx="5384637" cy="1788636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8304889" y="2102905"/>
            <a:ext cx="18737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dulation_Jun16</a:t>
            </a: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10124" y="2443662"/>
            <a:ext cx="5476875" cy="19050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8333990" y="4256639"/>
            <a:ext cx="18737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dulation_Jun18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56242" y="4625971"/>
            <a:ext cx="5430757" cy="1822845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8333990" y="6508909"/>
            <a:ext cx="20009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nodulation_Nov15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75693" y="0"/>
            <a:ext cx="10815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ure S1: Manhattan plots generated from single GWAS analysis for each season/year, separately for each trait</a:t>
            </a:r>
          </a:p>
        </p:txBody>
      </p:sp>
    </p:spTree>
    <p:extLst>
      <p:ext uri="{BB962C8B-B14F-4D97-AF65-F5344CB8AC3E}">
        <p14:creationId xmlns:p14="http://schemas.microsoft.com/office/powerpoint/2010/main" val="3243857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1</TotalTime>
  <Words>3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tena</dc:creator>
  <cp:lastModifiedBy>Atena Oladzad</cp:lastModifiedBy>
  <cp:revision>6</cp:revision>
  <dcterms:created xsi:type="dcterms:W3CDTF">2020-09-04T18:35:57Z</dcterms:created>
  <dcterms:modified xsi:type="dcterms:W3CDTF">2020-09-15T23:40:40Z</dcterms:modified>
</cp:coreProperties>
</file>